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  <p:sldId id="263" r:id="rId3"/>
    <p:sldId id="264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046717A-207C-65E6-9EB8-EDCD6353087E}" name="Katie Beck" initials="KB" userId="b46be623d9418839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254"/>
    <p:restoredTop sz="94595"/>
  </p:normalViewPr>
  <p:slideViewPr>
    <p:cSldViewPr snapToGrid="0">
      <p:cViewPr>
        <p:scale>
          <a:sx n="95" d="100"/>
          <a:sy n="95" d="100"/>
        </p:scale>
        <p:origin x="-996" y="-43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62678CC-2FD3-2D9D-40CC-94469E4257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B4F0B48-D0FD-019E-DB9C-30848A332A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51C2BBF-77A9-5335-5EB8-3FB3E5057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B9B762B-35BE-0128-F339-322245309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8D7E5E4-56B7-C7BA-05F7-1B225909E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487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0955137-17C2-F48B-4754-2CBA235BF0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DC627DB-BF6C-4879-A1A5-DDF753CB89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F9D2307-D2BB-D761-21C3-04EEA02CD5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81DEF3A-FC1B-B144-439F-1B1E7B824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CC4851F-7C6D-4E86-2626-D6494952D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659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89D84F58-800F-3D2F-BDDC-F791455C4A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BC49A02-8E20-CE22-B83E-A5898366AD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0C168AC-3A7C-9482-0868-5B85F76B3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D13FA3A-9E09-1103-7527-7ED6971E9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DF9A570-5843-C6FD-A872-E0A6C6546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239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79B20C1-954C-A1B4-960D-6BF6DF20CD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092A7DE-A0A4-F3E3-543F-758281A76E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78774AC-09AC-4D41-E8EA-E05C4F892B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9CA065F-0205-8C16-F793-2CDC7D629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993C984-CD1F-9D93-E233-A1E0FBD34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897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5E378DE-B021-08F8-DC0D-79424DED23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DEB8F47-C9EE-5E9F-D127-45CFB43EA7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07A1196-A4D3-89A0-87A3-A2E57885D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42057BC-7F46-5F1A-D005-EB5EE53789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1D7156B-D730-E384-7FBF-7ABBB9BF2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837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8885311-D12A-519B-13C0-16356BC460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AB4163E-52FB-5E56-3C58-0186056511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29061F9-311F-2122-AD62-018DFEF5A4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E681C2A-EC33-5759-59A1-72C9E5157C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CC63D9E-E716-61D1-2916-0C5E2B99E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EDE610E-14C4-6D26-6348-763C0FA0EA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997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CE8EE9F-08A2-0E3A-A61B-0D590C09FF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51E65B0-D843-3CB6-15AC-835B0CB8BE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4AD34D9-031B-0CFE-07ED-76FD12CE6A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60D935AB-6537-CAE0-1693-58B46614E9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814327BD-0DC7-B377-1AD0-3A85B9FFD0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3D7CB974-5DE6-1057-8CA4-574431776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950368D8-0A5B-3004-4459-4B9CCEB3B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6B88CA2C-66F4-3BBB-FACA-E043DF05F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718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5B6C567-858B-9CFB-7707-F077C42A49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C7742BED-A64C-7343-90E8-D2AC6DE76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FD47F9C6-CA48-C93D-D400-5464CFB455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0BF2F8AC-3526-5C1A-F1C9-B5B2C8145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645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59760E0A-3ED6-917A-AA61-2033C8BF6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44EC7ABE-107E-2CA4-F6DF-6ED07E8C7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F182878F-E485-0CAE-33AD-4A5B6DE7C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157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3B7A74A-BDE5-5BAC-71D1-278656A9FA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7F4D608-D531-6A9F-7D2B-056677A3F1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563697C2-B6DE-2C83-0E2A-0A5C6240EB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B8F32B0-4DCC-9B87-F5A0-2225B7529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A1459A8-18C4-57E6-AEE2-EE2F45AA7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47E0CF2-0BFD-B7C9-C365-A15CDBE3B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438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DA5E086-3B54-3759-6ADB-F8B4F36D1B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52A7AF03-3462-F6BE-DEEA-6C9BAEB23D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0B5C95AE-DB3D-EA4E-E3C2-B3B5174467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1DC5B17-E245-45A7-B0E8-AF0BE174D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FBEB2AD-FCF4-1EB4-2C71-9EAD667272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CF94BF5-00FE-2AE8-D71D-3B30D6BB4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729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129F24CD-62B9-22B5-1D5B-BCAFCA0A59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27412EE-F399-D759-1C28-726D9C3848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0C2F052-68E6-B206-6921-8252F1C32E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D0777-E0C6-3640-A20B-2A0A66C9A916}" type="datetimeFigureOut">
              <a:rPr lang="en-US" smtClean="0"/>
              <a:t>12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A40CDE9-5B23-6937-8CCC-989D467F83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DFA669C-6686-22ED-20BB-9FA21DE5B2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FEFB0-8346-F743-873C-E0B19DF4E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767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62ACB059-4D18-B7D1-BF3A-33409A93CD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7462286"/>
              </p:ext>
            </p:extLst>
          </p:nvPr>
        </p:nvGraphicFramePr>
        <p:xfrm>
          <a:off x="643467" y="1167425"/>
          <a:ext cx="10905068" cy="4720475"/>
        </p:xfrm>
        <a:graphic>
          <a:graphicData uri="http://schemas.openxmlformats.org/drawingml/2006/table">
            <a:tbl>
              <a:tblPr firstRow="1" firstCol="1" bandRow="1"/>
              <a:tblGrid>
                <a:gridCol w="1473523">
                  <a:extLst>
                    <a:ext uri="{9D8B030D-6E8A-4147-A177-3AD203B41FA5}">
                      <a16:colId xmlns:a16="http://schemas.microsoft.com/office/drawing/2014/main" xmlns="" val="1921575224"/>
                    </a:ext>
                  </a:extLst>
                </a:gridCol>
                <a:gridCol w="597660">
                  <a:extLst>
                    <a:ext uri="{9D8B030D-6E8A-4147-A177-3AD203B41FA5}">
                      <a16:colId xmlns:a16="http://schemas.microsoft.com/office/drawing/2014/main" xmlns="" val="170082507"/>
                    </a:ext>
                  </a:extLst>
                </a:gridCol>
                <a:gridCol w="597660">
                  <a:extLst>
                    <a:ext uri="{9D8B030D-6E8A-4147-A177-3AD203B41FA5}">
                      <a16:colId xmlns:a16="http://schemas.microsoft.com/office/drawing/2014/main" xmlns="" val="4041097094"/>
                    </a:ext>
                  </a:extLst>
                </a:gridCol>
                <a:gridCol w="597660">
                  <a:extLst>
                    <a:ext uri="{9D8B030D-6E8A-4147-A177-3AD203B41FA5}">
                      <a16:colId xmlns:a16="http://schemas.microsoft.com/office/drawing/2014/main" xmlns="" val="91007346"/>
                    </a:ext>
                  </a:extLst>
                </a:gridCol>
                <a:gridCol w="918791">
                  <a:extLst>
                    <a:ext uri="{9D8B030D-6E8A-4147-A177-3AD203B41FA5}">
                      <a16:colId xmlns:a16="http://schemas.microsoft.com/office/drawing/2014/main" xmlns="" val="3879483519"/>
                    </a:ext>
                  </a:extLst>
                </a:gridCol>
                <a:gridCol w="2655350">
                  <a:extLst>
                    <a:ext uri="{9D8B030D-6E8A-4147-A177-3AD203B41FA5}">
                      <a16:colId xmlns:a16="http://schemas.microsoft.com/office/drawing/2014/main" xmlns="" val="1283316651"/>
                    </a:ext>
                  </a:extLst>
                </a:gridCol>
                <a:gridCol w="818438">
                  <a:extLst>
                    <a:ext uri="{9D8B030D-6E8A-4147-A177-3AD203B41FA5}">
                      <a16:colId xmlns:a16="http://schemas.microsoft.com/office/drawing/2014/main" xmlns="" val="133908258"/>
                    </a:ext>
                  </a:extLst>
                </a:gridCol>
                <a:gridCol w="597660">
                  <a:extLst>
                    <a:ext uri="{9D8B030D-6E8A-4147-A177-3AD203B41FA5}">
                      <a16:colId xmlns:a16="http://schemas.microsoft.com/office/drawing/2014/main" xmlns="" val="608558021"/>
                    </a:ext>
                  </a:extLst>
                </a:gridCol>
                <a:gridCol w="597660">
                  <a:extLst>
                    <a:ext uri="{9D8B030D-6E8A-4147-A177-3AD203B41FA5}">
                      <a16:colId xmlns:a16="http://schemas.microsoft.com/office/drawing/2014/main" xmlns="" val="777097004"/>
                    </a:ext>
                  </a:extLst>
                </a:gridCol>
                <a:gridCol w="954026">
                  <a:extLst>
                    <a:ext uri="{9D8B030D-6E8A-4147-A177-3AD203B41FA5}">
                      <a16:colId xmlns:a16="http://schemas.microsoft.com/office/drawing/2014/main" xmlns="" val="547332254"/>
                    </a:ext>
                  </a:extLst>
                </a:gridCol>
                <a:gridCol w="1096640">
                  <a:extLst>
                    <a:ext uri="{9D8B030D-6E8A-4147-A177-3AD203B41FA5}">
                      <a16:colId xmlns:a16="http://schemas.microsoft.com/office/drawing/2014/main" xmlns="" val="909793981"/>
                    </a:ext>
                  </a:extLst>
                </a:gridCol>
              </a:tblGrid>
              <a:tr h="663559">
                <a:tc rowSpan="3">
                  <a:txBody>
                    <a:bodyPr/>
                    <a:lstStyle/>
                    <a:p>
                      <a:pPr algn="ct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udy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lection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parability of cases and controls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posure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 fontAlgn="t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 Score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Quality Rating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69287088"/>
                  </a:ext>
                </a:extLst>
              </a:tr>
              <a:tr h="3435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imary + additional factor (/2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 fontAlgn="t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t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1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60565" marR="160565" marT="80283" marB="80283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058818225"/>
                  </a:ext>
                </a:extLst>
              </a:tr>
              <a:tr h="57034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71205336"/>
                  </a:ext>
                </a:extLst>
              </a:tr>
              <a:tr h="336296"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hungu 2012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t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(/10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od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66100715"/>
                  </a:ext>
                </a:extLst>
              </a:tr>
              <a:tr h="336296"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raganov 202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228600"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t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(/10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od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80924860"/>
                  </a:ext>
                </a:extLst>
              </a:tr>
              <a:tr h="336296"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ermens 2018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t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(/10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od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12805192"/>
                  </a:ext>
                </a:extLst>
              </a:tr>
              <a:tr h="336296"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reed 2017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(/2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t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(/10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od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78494301"/>
                  </a:ext>
                </a:extLst>
              </a:tr>
              <a:tr h="336296"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uura 2023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(/2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t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8(/10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Good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51682863"/>
                  </a:ext>
                </a:extLst>
              </a:tr>
              <a:tr h="336296"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mith 202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(/2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t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8(/10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Good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2122185"/>
                  </a:ext>
                </a:extLst>
              </a:tr>
              <a:tr h="336296"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mith 202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                     2 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(/2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t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7(/10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Good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37733706"/>
                  </a:ext>
                </a:extLst>
              </a:tr>
              <a:tr h="591639"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dlewska 2014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(/2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t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8(/10)</a:t>
                      </a:r>
                      <a:endParaRPr lang="en-GB" sz="3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GB" sz="1600" b="0" i="0" u="none" strike="noStrike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Good</a:t>
                      </a:r>
                      <a:endParaRPr lang="en-GB" sz="3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20424" marR="120424" marT="167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4211196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694C8CB5-8F91-9B61-2073-46556D203003}"/>
              </a:ext>
            </a:extLst>
          </p:cNvPr>
          <p:cNvSpPr txBox="1"/>
          <p:nvPr/>
        </p:nvSpPr>
        <p:spPr>
          <a:xfrm>
            <a:off x="844952" y="358815"/>
            <a:ext cx="8914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Table 1</a:t>
            </a:r>
          </a:p>
        </p:txBody>
      </p:sp>
    </p:spTree>
    <p:extLst>
      <p:ext uri="{BB962C8B-B14F-4D97-AF65-F5344CB8AC3E}">
        <p14:creationId xmlns:p14="http://schemas.microsoft.com/office/powerpoint/2010/main" val="28144753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B1F2CE7D-B055-26C2-AB7D-9E9BBA5665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6650" y="825500"/>
            <a:ext cx="7378700" cy="5207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76E16195-54F6-E499-EF06-58A239EAF6B6}"/>
              </a:ext>
            </a:extLst>
          </p:cNvPr>
          <p:cNvSpPr txBox="1"/>
          <p:nvPr/>
        </p:nvSpPr>
        <p:spPr>
          <a:xfrm>
            <a:off x="844952" y="358815"/>
            <a:ext cx="4085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30931928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9618CA5D-9B49-BA10-978F-E12141BCD9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6650" y="825500"/>
            <a:ext cx="7378700" cy="5207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418BEF99-B9B5-67D4-6186-109A9B47966F}"/>
              </a:ext>
            </a:extLst>
          </p:cNvPr>
          <p:cNvSpPr txBox="1"/>
          <p:nvPr/>
        </p:nvSpPr>
        <p:spPr>
          <a:xfrm>
            <a:off x="844952" y="358815"/>
            <a:ext cx="4085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</a:t>
            </a:r>
          </a:p>
        </p:txBody>
      </p:sp>
    </p:spTree>
    <p:extLst>
      <p:ext uri="{BB962C8B-B14F-4D97-AF65-F5344CB8AC3E}">
        <p14:creationId xmlns:p14="http://schemas.microsoft.com/office/powerpoint/2010/main" val="17128654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B01DADDC-B8E9-7B08-F838-698A46C0B0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4123" y="1305131"/>
            <a:ext cx="7489041" cy="535608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E4CA252C-76E8-5643-9981-DF22ADC4E0F8}"/>
              </a:ext>
            </a:extLst>
          </p:cNvPr>
          <p:cNvSpPr txBox="1"/>
          <p:nvPr/>
        </p:nvSpPr>
        <p:spPr>
          <a:xfrm>
            <a:off x="844952" y="358815"/>
            <a:ext cx="4085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203006F0-843D-5148-AA05-6BDCFB33DBE1}"/>
              </a:ext>
            </a:extLst>
          </p:cNvPr>
          <p:cNvSpPr txBox="1"/>
          <p:nvPr/>
        </p:nvSpPr>
        <p:spPr>
          <a:xfrm>
            <a:off x="1643605" y="1689903"/>
            <a:ext cx="3287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ower GSH (patient group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C05CD4C7-C69E-554F-8621-8687607E7700}"/>
              </a:ext>
            </a:extLst>
          </p:cNvPr>
          <p:cNvSpPr txBox="1"/>
          <p:nvPr/>
        </p:nvSpPr>
        <p:spPr>
          <a:xfrm>
            <a:off x="8530542" y="1689903"/>
            <a:ext cx="2905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igher GSH (patient group)</a:t>
            </a:r>
          </a:p>
        </p:txBody>
      </p:sp>
    </p:spTree>
    <p:extLst>
      <p:ext uri="{BB962C8B-B14F-4D97-AF65-F5344CB8AC3E}">
        <p14:creationId xmlns:p14="http://schemas.microsoft.com/office/powerpoint/2010/main" val="1585607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1</TotalTime>
  <Words>185</Words>
  <Application>Microsoft Office PowerPoint</Application>
  <PresentationFormat>Custom</PresentationFormat>
  <Paragraphs>111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ie Bell</dc:creator>
  <cp:lastModifiedBy>E756380</cp:lastModifiedBy>
  <cp:revision>19</cp:revision>
  <dcterms:created xsi:type="dcterms:W3CDTF">2022-11-15T13:40:57Z</dcterms:created>
  <dcterms:modified xsi:type="dcterms:W3CDTF">2024-12-19T00:46:04Z</dcterms:modified>
</cp:coreProperties>
</file>